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  <p:sldId id="261" r:id="rId4"/>
    <p:sldId id="264" r:id="rId5"/>
    <p:sldId id="256" r:id="rId6"/>
    <p:sldId id="258" r:id="rId7"/>
    <p:sldId id="259" r:id="rId8"/>
    <p:sldId id="262" r:id="rId9"/>
    <p:sldId id="265" r:id="rId10"/>
    <p:sldId id="266" r:id="rId11"/>
    <p:sldId id="267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53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88647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624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703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5551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3026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0143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3230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591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9982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6055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3180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CB282-A686-4507-A458-B4CF22CF46E7}" type="datetimeFigureOut">
              <a:rPr lang="zh-CN" altLang="en-US" smtClean="0"/>
              <a:t>2024/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69C50-6BDC-4AD0-AB5C-BC188B0DBE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9317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6C0A05-798D-5505-960F-474F6117F4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381000" y="1122363"/>
            <a:ext cx="8382000" cy="2387600"/>
          </a:xfrm>
        </p:spPr>
        <p:txBody>
          <a:bodyPr>
            <a:noAutofit/>
          </a:bodyPr>
          <a:lstStyle/>
          <a:p>
            <a:r>
              <a:rPr lang="en-US" altLang="zh-CN" sz="3600" dirty="0">
                <a:latin typeface="Arial" panose="020B0604020202020204" pitchFamily="34" charset="0"/>
                <a:cs typeface="Arial" panose="020B0604020202020204" pitchFamily="34" charset="0"/>
              </a:rPr>
              <a:t>The sequencing analysis of the SCMV mutant prior to the inoculation of maize</a:t>
            </a:r>
            <a:endParaRPr lang="zh-CN" altLang="en-US" sz="3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859594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54CDA0E-C43C-892B-2983-31B4E016B4D4}"/>
              </a:ext>
            </a:extLst>
          </p:cNvPr>
          <p:cNvSpPr txBox="1"/>
          <p:nvPr/>
        </p:nvSpPr>
        <p:spPr>
          <a:xfrm>
            <a:off x="203200" y="186267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NIb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ED49DD34-BED5-1FD2-A32C-28892E69E08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366" y="555599"/>
            <a:ext cx="851126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02172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A4E5C34-51DF-15EC-524A-BE60F3D79DE4}"/>
              </a:ext>
            </a:extLst>
          </p:cNvPr>
          <p:cNvSpPr txBox="1"/>
          <p:nvPr/>
        </p:nvSpPr>
        <p:spPr>
          <a:xfrm>
            <a:off x="203200" y="186267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E63A58D-3094-0EFA-F1C1-628388C9DF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08652"/>
            <a:ext cx="9144000" cy="42406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51839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A0B0EA5D-B56E-21B7-0014-2B9AA3B6D983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1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4926B04-CDBC-A8E1-7C44-92CA1B75FFC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01672"/>
            <a:ext cx="9144000" cy="3180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9574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7AE5102-FD75-2220-AA45-C6D94F109483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C-Pro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654FF35-3530-CB91-F90A-33DC609C3E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6141"/>
            <a:ext cx="9144000" cy="61818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80726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1F7028F0-8854-07AF-79BA-A9837ABBE880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3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854C2EC-FE4D-E49C-1172-02D78191A9E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043608"/>
            <a:ext cx="9144000" cy="4770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16047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8EFA1833-5789-0404-34C3-9F9DCB32C850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K1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14F1ACC-78EA-FFB1-C4D9-0AE09017AC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100" y="1905000"/>
            <a:ext cx="4495800" cy="304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10794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61E3761-3241-BF9C-3B70-7BF0015B56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4100" y="1921934"/>
            <a:ext cx="4495800" cy="24384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F881FFA-9B09-4864-F22F-39AEDFD5892B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K2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55915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6B68426-2705-5AF5-D9DC-4943189448D8}"/>
              </a:ext>
            </a:extLst>
          </p:cNvPr>
          <p:cNvSpPr txBox="1"/>
          <p:nvPr/>
        </p:nvSpPr>
        <p:spPr>
          <a:xfrm>
            <a:off x="186267" y="127001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I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095F0F94-0F1A-450F-8756-D61815E888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6243" y="127001"/>
            <a:ext cx="739378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86324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42F3289B-8E5F-CC9A-594A-24880C5C41FE}"/>
              </a:ext>
            </a:extLst>
          </p:cNvPr>
          <p:cNvSpPr txBox="1"/>
          <p:nvPr/>
        </p:nvSpPr>
        <p:spPr>
          <a:xfrm>
            <a:off x="203200" y="186267"/>
            <a:ext cx="1710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VPg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4C7F4769-8F26-963C-52F6-33D327FC96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13316"/>
            <a:ext cx="9144000" cy="26313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21113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57391BF-B425-353E-F6AA-012345057116}"/>
              </a:ext>
            </a:extLst>
          </p:cNvPr>
          <p:cNvSpPr txBox="1"/>
          <p:nvPr/>
        </p:nvSpPr>
        <p:spPr>
          <a:xfrm>
            <a:off x="203200" y="186267"/>
            <a:ext cx="2108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NIa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-Pro</a:t>
            </a:r>
            <a:r>
              <a:rPr lang="zh-CN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6ED06B5-67AA-BDAA-503F-6E54203254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638566"/>
            <a:ext cx="9144000" cy="3580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8574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076</TotalTime>
  <Words>33</Words>
  <Application>Microsoft Office PowerPoint</Application>
  <PresentationFormat>全屏显示(4:3)</PresentationFormat>
  <Paragraphs>11</Paragraphs>
  <Slides>1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主题​​</vt:lpstr>
      <vt:lpstr>The sequencing analysis of the SCMV mutant prior to the inoculation of maiz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sequencing analysis of the SCMV mutant prior to the inoculation of maize</dc:title>
  <dc:creator>雯 袁</dc:creator>
  <cp:lastModifiedBy>雯 袁</cp:lastModifiedBy>
  <cp:revision>4</cp:revision>
  <dcterms:created xsi:type="dcterms:W3CDTF">2023-12-21T09:56:02Z</dcterms:created>
  <dcterms:modified xsi:type="dcterms:W3CDTF">2024-01-09T07:15:33Z</dcterms:modified>
</cp:coreProperties>
</file>